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80" r:id="rId2"/>
    <p:sldId id="295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5715678-AE43-3948-BF03-53C5B3A70A8D}" v="1" dt="2019-04-10T10:31:33.098"/>
    <p1510:client id="{BADDEF52-CA2C-4A41-9F11-DC70725C5199}" v="1" dt="2019-04-10T10:10:23.35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94"/>
  </p:normalViewPr>
  <p:slideViewPr>
    <p:cSldViewPr snapToGrid="0" snapToObjects="1">
      <p:cViewPr varScale="1">
        <p:scale>
          <a:sx n="89" d="100"/>
          <a:sy n="89" d="100"/>
        </p:scale>
        <p:origin x="346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eborah Lipski" userId="cd64e408eec4740c" providerId="LiveId" clId="{F5715678-AE43-3948-BF03-53C5B3A70A8D}"/>
    <pc:docChg chg="custSel addSld delSld modSld">
      <pc:chgData name="Deborah Lipski" userId="cd64e408eec4740c" providerId="LiveId" clId="{F5715678-AE43-3948-BF03-53C5B3A70A8D}" dt="2019-04-10T10:31:39.147" v="2" actId="478"/>
      <pc:docMkLst>
        <pc:docMk/>
      </pc:docMkLst>
      <pc:sldChg chg="del">
        <pc:chgData name="Deborah Lipski" userId="cd64e408eec4740c" providerId="LiveId" clId="{F5715678-AE43-3948-BF03-53C5B3A70A8D}" dt="2019-04-10T10:31:28.675" v="0" actId="2696"/>
        <pc:sldMkLst>
          <pc:docMk/>
          <pc:sldMk cId="412340844" sldId="278"/>
        </pc:sldMkLst>
      </pc:sldChg>
      <pc:sldChg chg="add">
        <pc:chgData name="Deborah Lipski" userId="cd64e408eec4740c" providerId="LiveId" clId="{F5715678-AE43-3948-BF03-53C5B3A70A8D}" dt="2019-04-10T10:31:33.098" v="1"/>
        <pc:sldMkLst>
          <pc:docMk/>
          <pc:sldMk cId="351546516" sldId="280"/>
        </pc:sldMkLst>
      </pc:sldChg>
      <pc:sldChg chg="delSp add">
        <pc:chgData name="Deborah Lipski" userId="cd64e408eec4740c" providerId="LiveId" clId="{F5715678-AE43-3948-BF03-53C5B3A70A8D}" dt="2019-04-10T10:31:39.147" v="2" actId="478"/>
        <pc:sldMkLst>
          <pc:docMk/>
          <pc:sldMk cId="4044172062" sldId="295"/>
        </pc:sldMkLst>
        <pc:spChg chg="del">
          <ac:chgData name="Deborah Lipski" userId="cd64e408eec4740c" providerId="LiveId" clId="{F5715678-AE43-3948-BF03-53C5B3A70A8D}" dt="2019-04-10T10:31:39.147" v="2" actId="478"/>
          <ac:spMkLst>
            <pc:docMk/>
            <pc:sldMk cId="4044172062" sldId="295"/>
            <ac:spMk id="4" creationId="{3E03A047-F9F8-5E43-B7D6-7B76CDB88856}"/>
          </ac:spMkLst>
        </pc:spChg>
      </pc:sldChg>
    </pc:docChg>
  </pc:docChgLst>
  <pc:docChgLst>
    <pc:chgData name="Deborah Lipski" userId="cd64e408eec4740c" providerId="LiveId" clId="{BADDEF52-CA2C-4A41-9F11-DC70725C5199}"/>
    <pc:docChg chg="custSel addSld delSld modSld">
      <pc:chgData name="Deborah Lipski" userId="cd64e408eec4740c" providerId="LiveId" clId="{BADDEF52-CA2C-4A41-9F11-DC70725C5199}" dt="2019-04-10T10:10:27.146" v="2" actId="478"/>
      <pc:docMkLst>
        <pc:docMk/>
      </pc:docMkLst>
      <pc:sldChg chg="del">
        <pc:chgData name="Deborah Lipski" userId="cd64e408eec4740c" providerId="LiveId" clId="{BADDEF52-CA2C-4A41-9F11-DC70725C5199}" dt="2019-04-10T10:10:24.550" v="1" actId="2696"/>
        <pc:sldMkLst>
          <pc:docMk/>
          <pc:sldMk cId="2324155290" sldId="256"/>
        </pc:sldMkLst>
      </pc:sldChg>
      <pc:sldChg chg="delSp add">
        <pc:chgData name="Deborah Lipski" userId="cd64e408eec4740c" providerId="LiveId" clId="{BADDEF52-CA2C-4A41-9F11-DC70725C5199}" dt="2019-04-10T10:10:27.146" v="2" actId="478"/>
        <pc:sldMkLst>
          <pc:docMk/>
          <pc:sldMk cId="412340844" sldId="278"/>
        </pc:sldMkLst>
        <pc:spChg chg="del">
          <ac:chgData name="Deborah Lipski" userId="cd64e408eec4740c" providerId="LiveId" clId="{BADDEF52-CA2C-4A41-9F11-DC70725C5199}" dt="2019-04-10T10:10:27.146" v="2" actId="478"/>
          <ac:spMkLst>
            <pc:docMk/>
            <pc:sldMk cId="412340844" sldId="278"/>
            <ac:spMk id="8" creationId="{66D98C6E-2DB1-174B-B538-28C4EB7EF7B6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043666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210804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22685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50085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3041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094058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23580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92970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5626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572634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64162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555778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/>
        </p:nvGraphicFramePr>
        <p:xfrm>
          <a:off x="188640" y="467544"/>
          <a:ext cx="6480720" cy="8251667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23424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9040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67960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3204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3204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1602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36004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80020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389539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546565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</a:tblGrid>
              <a:tr h="149736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/>
                        <a:t>Gene I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/>
                        <a:t>LogF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/>
                        <a:t>FD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/>
                        <a:t>Gene I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/>
                        <a:t>LogF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/>
                        <a:t>FD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0811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tla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 err="1"/>
                        <a:t>cytotoxic</a:t>
                      </a:r>
                      <a:r>
                        <a:rPr lang="en-US" sz="600" u="none" strike="noStrike" dirty="0"/>
                        <a:t> T-lymphocyte-associated protein 4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dirty="0"/>
                        <a:t>10,3199827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dirty="0"/>
                        <a:t>2,72E-06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dirty="0"/>
                        <a:t>61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 err="1"/>
                        <a:t>Itk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BE" sz="600" u="none" strike="noStrike" dirty="0"/>
                        <a:t>IL2 </a:t>
                      </a:r>
                      <a:r>
                        <a:rPr lang="fr-BE" sz="600" u="none" strike="noStrike" dirty="0" err="1"/>
                        <a:t>inducible</a:t>
                      </a:r>
                      <a:r>
                        <a:rPr lang="fr-BE" sz="600" u="none" strike="noStrike" dirty="0"/>
                        <a:t> T </a:t>
                      </a:r>
                      <a:r>
                        <a:rPr lang="fr-BE" sz="600" u="none" strike="noStrike" dirty="0" err="1"/>
                        <a:t>cell</a:t>
                      </a:r>
                      <a:r>
                        <a:rPr lang="fr-BE" sz="600" u="none" strike="noStrike" dirty="0"/>
                        <a:t> kinase</a:t>
                      </a:r>
                      <a:endParaRPr lang="fr-BE" sz="6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2332192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1119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cl2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hemokine ligand 2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0,057663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55E-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6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Il2rg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600" u="none" strike="noStrike"/>
                        <a:t>interleukin 2 receptor, gamma chain</a:t>
                      </a:r>
                      <a:endParaRPr lang="sv-SE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2139659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04152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d3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D3 antigen, epsilon polypeptid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9,4484311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,17E-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6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Tgfbi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transforming growth factor, beta induced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2036006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17636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Gimap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GTPase, IMAP family member 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9,3867140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6,54E-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6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lec7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-type lectin domain family 7, member 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1983104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43529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d3g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D3 antigen, gamma polypeptid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9,3688381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84E-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6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Laptm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lysosomal-associated protein transmembrane 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1010678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,92E-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90811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Ms4a6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membrane-spanning 4-domains, subfamily A, member 6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9,3315491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6,48E-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6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Hmha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N/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0695115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02182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2548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Il17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interleukin 17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9,2970558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05414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6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Itgal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integrin alpha L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049081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5,91E-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2548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Il2r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interleukin 2 receptor, alpha cha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9,2458561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65E-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6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Plac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placenta-specific 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0252793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68436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85743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H2-Eb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histocompatibility 2, class II antigen E bet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8,7157789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,99E-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6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cnd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yclin D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9538964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01986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Themis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thymocyte selection associated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7,9090082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8,57E-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7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Selplg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selectin, platelet ligand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882867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,49E-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Sl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src-like adaptor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7,7598447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,07E-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7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Arhgap3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Rho GTPase activating protein 3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7742311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101123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49237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cr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hemokine receptor 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7,7568507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,26E-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7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Ifi20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interferon activated gene 20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7704963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36394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90811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sf2r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olony stimulating factor 2 receptor, beta, low-affinity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7,6612234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01187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7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Igt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interferon gamma induced GTPas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6764551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,78E-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91383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cr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hemokine receptor 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7,5954941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69E-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7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S100a1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S100 calcium binding protein A1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6735729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23251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05184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H2-A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histocompatibility 2, class II antigen A, alph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7,3004685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,31E-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7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H2-K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histocompatibility 2, K1, K regio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6546517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5,62E-0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72008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yti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ytohesin 1 interacting prote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7,2455916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95E-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7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Lck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lymphocyte protein tyrosine kinas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6518566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06201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90811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Ms4a4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membrane-spanning 4-domains, subfamily A, member 4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7,1309957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65E-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7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Scube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signal peptide, CUB domain, EGF-like 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6405532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02077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09428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Stat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signal transducer and activator of transcription 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7,0625632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dirty="0"/>
                        <a:t>0,00010166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7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S100a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S100 calcium binding protein A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5972623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53161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2548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Il18r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interleukin 18 receptor 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6,9946287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,72E-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7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Lad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ladin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572621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,27E-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2548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Lsp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lymphocyte specific 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6,7249361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81E-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8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Jak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Janus kinase 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5517283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02749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90811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dirty="0"/>
                        <a:t>21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/>
                        <a:t>P2ry10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 err="1"/>
                        <a:t>purinergic</a:t>
                      </a:r>
                      <a:r>
                        <a:rPr lang="en-US" sz="600" u="none" strike="noStrike" dirty="0"/>
                        <a:t> receptor P2Y, G-protein coupled 10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dirty="0"/>
                        <a:t>6,39536933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49E-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dirty="0"/>
                        <a:t>81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/>
                        <a:t>Myo1f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/>
                        <a:t>myosin IF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dirty="0"/>
                        <a:t>3,55167031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dirty="0"/>
                        <a:t>0,01716794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11281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H2-Ab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 err="1"/>
                        <a:t>histocompatibility</a:t>
                      </a:r>
                      <a:r>
                        <a:rPr lang="en-US" sz="600" u="none" strike="noStrike" dirty="0"/>
                        <a:t> 2, class II antigen A, beta 1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6,3868752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03E-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8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d27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D274 antige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5260901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04915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Icos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inducible T cell co-stimulator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6,3576725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,42E-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8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Irgm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immunity-related GTPase family M member 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4824553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79E-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Gimap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GTPase, IMAP family member 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6,3299065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01820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8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S100a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S100 calcium binding protein A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4393645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43477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d7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D74 antige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6,253122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,72E-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8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Ptpn2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protein tyrosine phosphatase, non-receptor type 2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4135563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6,97E-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2548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Il7r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interleukin 7 receptor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6,2017142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9,69E-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8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Gfa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glial fibrillary acidic prote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4041535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220156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2548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Ikzf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IKAROS family zinc finger 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6,2008795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01968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8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Shisa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shisa family member 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389904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,74E-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Sh2d2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SH2 domain containing 2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6,1831765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94E-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8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Irf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interferon regulatory factor 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3461774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03061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Sp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sialophor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6,11347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03E-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8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Fxyd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FXYD domain-containing ion transport regulator 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3435619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86E-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Rac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RAS-related C3 botulinum substrate 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5,8519881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81E-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9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Parp1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poly (ADP-ribose) polymerase family, member 1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3249724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,60E-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90811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Fy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FYN binding prote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5,6568418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,78E-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9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Apobec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apolipoprotein B mRNA editing enzyme, catalytic polypeptide 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3111957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73205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Dock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dedicator of cyto-kinesis 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5,6513335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,78E-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9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Zc3hav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zinc finger CCCH type, antiviral 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2614493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97E-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Nlrc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NLR family, CARD domain containing 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5,4906288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46E-0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9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xcr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/>
                        <a:t>chemokine (C-X-C motif) receptor 4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2568660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8363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12548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Il2r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interleukin 2 receptor, beta cha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5,4427921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5,41E-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9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Lcn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lipocalin 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2392666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01485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Gm196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predicted gene 196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5,348196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11056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9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B2m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beta-2 microglobul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23112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,42E-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59393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Ptprc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protein tyrosine phosphatase, receptor type, C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5,3387116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,72E-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9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Ptk2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PTK2 protein tyrosine kinase 2 bet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2149011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16118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84606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d2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D28 antige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5,1994676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0113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9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AW11201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expressed sequence AW11201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2137696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371335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Gpr13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G protein-coupled receptor 13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5,1452031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07992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9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Fgf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fibroblast growth factor 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2115828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,72E-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Rgs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regulator of G-protein signaling 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5,142258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7,19E-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9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Baz1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bromodomain adjacent to zinc finger domain 1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2115714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62597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12548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Runx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runt related transcription factor 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5,0983418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03412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0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Nudt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nudix hydrolase 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2079143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9,59E-0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Lcp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lymphocyte cytosolic protein 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9611258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01107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0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H2-D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histocompatibility 2, D region locus 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1927975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81E-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1"/>
                  </a:ext>
                </a:extLst>
              </a:tr>
              <a:tr h="10280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d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D4 antige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9527766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,49E-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0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Srg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serglyc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1513530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dirty="0"/>
                        <a:t>0,00176369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2"/>
                  </a:ext>
                </a:extLst>
              </a:tr>
              <a:tr h="121336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Serpina3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serpin family A member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9183227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7,78E-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0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oro1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oronin, actin binding protein 1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1214270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50923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3"/>
                  </a:ext>
                </a:extLst>
              </a:tr>
              <a:tr h="6312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omplement component 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8662174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86E-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0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Trim30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tripartite motif-containing 30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1148078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50501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4"/>
                  </a:ext>
                </a:extLst>
              </a:tr>
              <a:tr h="1921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Itgb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integrin beta 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8014401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03579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Pik3cg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phosphatidylinositol-4,5-bisphosphate 3-kinase catalytic subunit gamm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1093375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98939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5"/>
                  </a:ext>
                </a:extLst>
              </a:tr>
              <a:tr h="10527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Wdfy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WD repeat and FYVE domain containing 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7951689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02049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Adam1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a disintegrin and metallopeptidase domain 1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1032334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10715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6"/>
                  </a:ext>
                </a:extLst>
              </a:tr>
              <a:tr h="63548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Mki6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/>
                        <a:t>antigen identified by monoclonal antibody </a:t>
                      </a:r>
                      <a:r>
                        <a:rPr lang="en-US" sz="600" u="none" strike="noStrike" dirty="0" err="1"/>
                        <a:t>Ki</a:t>
                      </a:r>
                      <a:r>
                        <a:rPr lang="en-US" sz="600" u="none" strike="noStrike" dirty="0"/>
                        <a:t> 67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7810325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24300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0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Arhgdi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Rho, GDP dissociation inhibitor (GDI) bet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0759473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02919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7"/>
                  </a:ext>
                </a:extLst>
              </a:tr>
              <a:tr h="12548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Edn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endothelin 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7370814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,87E-0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0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Elf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E74-like factor 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0755728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32164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8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Lyz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lysozyme 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6746406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06295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0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Plbd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phospholipase B domain containing 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0257177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63379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9"/>
                  </a:ext>
                </a:extLst>
              </a:tr>
              <a:tr h="12548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5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Bcl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B cell leukemia/lymphoma 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6600110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,69E-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1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nn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alponin 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0108953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94755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0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5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cl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hemokine ligand 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5930601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02828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1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Tgfb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transforming growth factor, beta 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3,0007497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144625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1"/>
                  </a:ext>
                </a:extLst>
              </a:tr>
              <a:tr h="8140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5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Tap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transporter 1, ATP-binding cassette, sub-family 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512214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9,77E-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1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Rassf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Ras association domain family member 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,9801655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20253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2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5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Bin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bridging integrator 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4770381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6,77E-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1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Irgm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immunity-related GTPase family M member 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,974849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01416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3"/>
                  </a:ext>
                </a:extLst>
              </a:tr>
              <a:tr h="12548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5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d5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D52 antige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4264532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97E-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1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Rin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Ras and Rab interactor 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,9466679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78839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4"/>
                  </a:ext>
                </a:extLst>
              </a:tr>
              <a:tr h="190811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5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Tnfrsf1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/>
                        <a:t>tumor necrosis factor receptor </a:t>
                      </a:r>
                      <a:r>
                        <a:rPr lang="en-US" sz="600" u="none" strike="noStrike" dirty="0" err="1"/>
                        <a:t>superfamily</a:t>
                      </a:r>
                      <a:r>
                        <a:rPr lang="en-US" sz="600" u="none" strike="noStrike" dirty="0"/>
                        <a:t>, member 1b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4207943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,49E-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1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Parp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poly (ADP-ribose) polymerase family, member 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,9416543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01752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5"/>
                  </a:ext>
                </a:extLst>
              </a:tr>
              <a:tr h="36391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5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Ikzf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IKAROS family zinc finger 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4005040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8,56E-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1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Birc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baculoviral IAP repeat-containing 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,9043542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135324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6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5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Fgl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/>
                        <a:t>fibrinogen-like protein 2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375519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07412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1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yb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ytochrome b-245, beta polypeptid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,8996034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dirty="0"/>
                        <a:t>0,04323914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7"/>
                  </a:ext>
                </a:extLst>
              </a:tr>
              <a:tr h="93243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5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Il1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interleukin 1 beta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3311093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33395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1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Ets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600" u="none" strike="noStrike"/>
                        <a:t>E26 avian leukemia oncogene 1, 5' domain</a:t>
                      </a:r>
                      <a:endParaRPr lang="it-IT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,8883155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,30E-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8"/>
                  </a:ext>
                </a:extLst>
              </a:tr>
              <a:tr h="35036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5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Lcp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lymphocyte cytosolic protein 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3037451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13443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11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Gbp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guanylate binding protein 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,8134849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0,0046817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9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dirty="0"/>
                        <a:t>60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d5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CD53 antige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4,2745443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dirty="0"/>
                        <a:t>1,03E-05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dirty="0"/>
                        <a:t>120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Scarna3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/>
                        <a:t>small Cajal body-specific RNA 3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/>
                        <a:t>2,7538780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 dirty="0"/>
                        <a:t>0,00404432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15465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/>
        </p:nvGraphicFramePr>
        <p:xfrm>
          <a:off x="188640" y="467544"/>
          <a:ext cx="6480720" cy="4827171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23424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9040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67960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3204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3204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1602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36004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80020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389539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546565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</a:tblGrid>
              <a:tr h="149736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/>
                        <a:t>Gene I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/>
                        <a:t>LogF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/>
                        <a:t>FD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/>
                        <a:t>Gene I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/>
                        <a:t>LogF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/>
                        <a:t>FD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0811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2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Runx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runt related transcription factor 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70722759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082627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5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Runx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runt related transcription factor 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,3426921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,01456965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2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tss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athepsin S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7048539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003688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5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Serping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erine peptidase inhibitor, clade G, member 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3046126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123440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2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itaf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PS-induced TN factor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67455749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2043395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54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Ahnak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HNAK nucleoprotein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29947734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51E-05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24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t8sia4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T8 alpha-N-acetyl-neuraminide alpha-2,8-sialyltransferase 4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6643703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0463435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55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2-T2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histocompatibility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2, T region locus 2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2961408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146205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25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Ucp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uncoupling protein 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6390918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007323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5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tsh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cathepsin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H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2580556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139552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90811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2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Inpp5d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inositol polyphosphate-5-phosphatase D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6337122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0116875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5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ckap1l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CK associated protein 1 like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2473151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2765974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2548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2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2m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lpha-2-macroglobulin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6326154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024080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58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rap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GRB2-related adaptor protein 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23760948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235259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2548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28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bp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uanylate binding protein 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6223855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0081209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59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Irf9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interferon regulatory factor 9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2348869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69E-0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85743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29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yo1g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yosin IG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60773569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0320505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0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yn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LYN proto-oncogene, </a:t>
                      </a:r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Src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family tyrosine </a:t>
                      </a:r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kinas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2342634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237023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30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mnl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ormin-like 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59266268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0684364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ocs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suppressor of cytokine signaling 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2016268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,78E-05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3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Rfx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regulatory factor X, 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58732169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,19E-0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agln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transgelin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1948419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060014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49237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3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Zbtb7c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zinc finger and BTB domain containing 7C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5740083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1412808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4b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complement component 4B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1856433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261820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90811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3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Dock10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dedicator of cytokinesis 10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5615282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008890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4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rim2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tripartite motif-containing 2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,1833215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12549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91383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34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Dtx3l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deltex 3-like, E3 ubiquitin ligase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55993409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001986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5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dgre5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adhesion G protein-coupled receptor E5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,18304068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19052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05184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35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Irf4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interferon regulatory factor 4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5548693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183279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p100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uclear antigen Sp100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,17856824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3765328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72008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3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es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estis derived transcript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54591139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211484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Runx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runt related transcription factor 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,1322745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0995908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90811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3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colce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rocollagen C-endopeptidase enhancer protein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5249179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0029199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8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Ifi30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interferon gamma inducible protein 30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,11497724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25749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09428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38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tpn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rotein tyrosine phosphatase, non-receptor type 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5042169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3924215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9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rkcd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rotein </a:t>
                      </a:r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kinase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C, delta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,08671139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372227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2548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39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gif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GFB-induced factor homeobox 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4992661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378951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70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ap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ransporter 2, ATP-binding cassette, sub-family B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,0864783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232968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2548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40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Itgb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integrin beta 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4863037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2722585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7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osl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os-like antigen 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,0567328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0676868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90811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4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im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roviral integration site 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4805267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0408588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7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rrc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eucine rich repeat containing 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,0329922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42E-0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11281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4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ntxr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nthrax toxin receptor 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47777274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,99E-08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7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ebpd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CAAT/enhancer binding protein (C/EBP), delta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,02678389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010604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4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oro2a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oronin, actin binding protein 2A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4565530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343204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74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Btc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betacellulin, epidermal growth factor family member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,02159888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84E-0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44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2-Q4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istocompatibility 2, Q region locus 4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45340535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0034988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75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mem176a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ransmembrane protein 176A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,01339144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3505244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45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rag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EAK1 related kinase activating pseudokinase 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4368275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306732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7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Oasl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'-5' oligoadenylate synthetase-like 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,0008110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0392279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2548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4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Itgae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integrin alpha E, epithelial-associated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4310867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129035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7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Olfm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olfactomedin 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2,0292155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235259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25489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4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ramd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RAM domain containing 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38288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236589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78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alnt1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UDP-N-acetyl-alpha-D-</a:t>
                      </a:r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galactosamine:polypeptide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N-</a:t>
                      </a:r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acetylgalactosaminyltransferase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1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2,225195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445561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48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tat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ignal transducer and activator of transcription 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37934193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,59E-0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79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Kcnj5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otassium inwardly-rectifying channel, subfamily J, member 5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2,3446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,0125709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49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arp1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oly (ADP-ribose) polymerase family, member 1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3591311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001348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80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alb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albindin 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2,394461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,0002101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30215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50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peg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acrophage expressed gene 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3505198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026106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8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cdhb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rotocadherin beta 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2,8970895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,0081607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90811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5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Wipf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WAS/WASL interacting protein family, member 1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33493335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,00223487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82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931408D14Rik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/A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3,5490199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,02462856</a:t>
                      </a:r>
                    </a:p>
                  </a:txBody>
                  <a:tcPr marL="9525" marR="9525" marT="9525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4417206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1611</Words>
  <Application>Microsoft Macintosh PowerPoint</Application>
  <PresentationFormat>Format A4 (210 x 297 mm)</PresentationFormat>
  <Paragraphs>922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eborah Lipski</dc:creator>
  <cp:lastModifiedBy>Deborah Lipski</cp:lastModifiedBy>
  <cp:revision>1</cp:revision>
  <dcterms:created xsi:type="dcterms:W3CDTF">2019-04-10T10:03:16Z</dcterms:created>
  <dcterms:modified xsi:type="dcterms:W3CDTF">2019-04-10T10:34:24Z</dcterms:modified>
</cp:coreProperties>
</file>